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157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CC8AE371-0FFE-4AB2-B79A-6298C00294D2}" v="36" dt="2023-02-20T13:27:51.206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10" d="100"/>
          <a:sy n="110" d="100"/>
        </p:scale>
        <p:origin x="552" y="108"/>
      </p:cViewPr>
      <p:guideLst>
        <p:guide orient="horz" pos="2160"/>
        <p:guide pos="157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3C3357F6-97A2-40D1-82F0-2D296C6F1EA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4B582BB6-D18A-43AB-805E-E20AF7D1725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A8F8EAAB-F3FA-4D1C-99F7-95DA8F529B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0B0716-A822-4170-BFBF-26C425134E20}" type="datetimeFigureOut">
              <a:rPr lang="it-IT" smtClean="0"/>
              <a:t>20/02/20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BA4EFEAA-3DEB-4CEC-8B88-F8C9E79AA2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E2D2A507-0274-42C3-892F-B037CA440A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D522D7-FB83-401B-B905-A026F952479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42950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C981F3C-91F6-4A19-BB0A-69654E19D23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99F303B6-0650-4AE5-B14D-582FD6D32DA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CE389299-7B15-4A75-B1D2-1D55E18A48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0B0716-A822-4170-BFBF-26C425134E20}" type="datetimeFigureOut">
              <a:rPr lang="it-IT" smtClean="0"/>
              <a:t>20/02/20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72FA6C93-0AD9-4A6D-A482-8DF665FBC4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2473DB42-855B-4C87-91DF-BC28340CEC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D522D7-FB83-401B-B905-A026F952479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895815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FCBC6408-DB11-4050-AAFE-5577C6DFD79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BF6C0119-9D30-4595-813B-748C5A95E66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72CF6057-7AF0-437E-9C85-16913E2E38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0B0716-A822-4170-BFBF-26C425134E20}" type="datetimeFigureOut">
              <a:rPr lang="it-IT" smtClean="0"/>
              <a:t>20/02/20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1ABF94F9-7CA5-4E31-87E0-473BF3051A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0AFBB730-D8BA-4DED-87D0-C50D7FF2CF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D522D7-FB83-401B-B905-A026F952479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331007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1D291A7A-4107-49C2-9D0B-51C837C9F8B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7517421C-5BAE-4F54-80C4-9AD563BAD6D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F2909B0E-6DB1-45ED-8AFD-E5454D63AB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0B0716-A822-4170-BFBF-26C425134E20}" type="datetimeFigureOut">
              <a:rPr lang="it-IT" smtClean="0"/>
              <a:t>20/02/20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7602C3CE-3D57-4E75-B730-7E526B9A3C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C99CC842-39DD-4EE4-A75F-60887ADEF0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D522D7-FB83-401B-B905-A026F952479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974810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2A8F2179-F2E2-4F7F-88D5-2475F903CF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DC2082A8-A4A1-4A4E-9DC8-50CEA5D9F8F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90A6F444-F818-47A9-B5DC-BC11DE69B3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0B0716-A822-4170-BFBF-26C425134E20}" type="datetimeFigureOut">
              <a:rPr lang="it-IT" smtClean="0"/>
              <a:t>20/02/20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2C63022E-BC0B-46DA-A2BE-E8D0396217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4F4D7E54-B902-4692-8891-3B17BC332F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D522D7-FB83-401B-B905-A026F952479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284240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0217D25E-7AF3-4378-AC9E-0933A8AA82F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0C8965C7-F8D2-434C-AD9B-936764A8F7D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614D0914-A602-499E-8135-C8B44A0E6EC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4485A4C7-47B7-4B80-942A-2907FF9913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0B0716-A822-4170-BFBF-26C425134E20}" type="datetimeFigureOut">
              <a:rPr lang="it-IT" smtClean="0"/>
              <a:t>20/02/2023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3655A17F-CCC9-4D22-802B-5E6A3F6CD2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B7100A26-3180-4797-8AD2-DEA8DE4889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D522D7-FB83-401B-B905-A026F952479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280753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900D4839-2628-4A0A-8426-55F5044D9AA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8BDE73DB-B7C0-445D-8DCF-04D1D4069B2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7620C218-0A01-4AA2-A73E-34D56888028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3463086A-3347-4DDA-A38F-B9889018399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3BDB0379-7CBA-40BA-8087-782CBC81F2A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31211733-4DE6-4A34-A9BC-9520D3E7ED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0B0716-A822-4170-BFBF-26C425134E20}" type="datetimeFigureOut">
              <a:rPr lang="it-IT" smtClean="0"/>
              <a:t>20/02/2023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5665C2B6-E7B3-4C9C-9A78-DE8F2DB416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3428FCC5-A114-4F0A-8EF7-33DC126929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D522D7-FB83-401B-B905-A026F952479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778376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BE612E2C-1FC1-43FB-94FB-03E6FBC9750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50AC24FA-43D2-4B61-8CF6-389DE9F5CB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0B0716-A822-4170-BFBF-26C425134E20}" type="datetimeFigureOut">
              <a:rPr lang="it-IT" smtClean="0"/>
              <a:t>20/02/2023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13020470-D812-454F-BAE4-8A96E5AD6C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8916DBF0-2282-4319-B950-BA3C7F3797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D522D7-FB83-401B-B905-A026F952479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042236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A0BAD995-240F-4BF3-983F-34F3D65A6C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0B0716-A822-4170-BFBF-26C425134E20}" type="datetimeFigureOut">
              <a:rPr lang="it-IT" smtClean="0"/>
              <a:t>20/02/2023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0D148D11-CD4F-4B23-BED9-72C47D8BE7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D20ABE06-16C7-481D-A73A-913E9D2FC5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D522D7-FB83-401B-B905-A026F952479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519478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FDD82BFF-4BD2-4906-851C-6B0FFD0BF2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63F7BEB9-BBC5-4787-BE39-EB1D3B0CC99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AA563F37-3E4A-48A6-980A-6F0CDEE3B9D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8B0F20E4-C5D6-4906-A863-0E2BC79911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0B0716-A822-4170-BFBF-26C425134E20}" type="datetimeFigureOut">
              <a:rPr lang="it-IT" smtClean="0"/>
              <a:t>20/02/2023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C35EA822-FB24-466B-9C2A-327D424371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1A2204F9-39BD-48E0-99D3-04C9C4AF32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D522D7-FB83-401B-B905-A026F952479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581608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CD91852-DF75-4E88-B2C4-23E27625B7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6D2D2BFB-0CD7-4450-B064-71D839F27C2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8B2DE2FE-E129-48D8-92F2-A114AEFB7B6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B5AC05A9-C6E0-4021-BDFA-361071BA2F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0B0716-A822-4170-BFBF-26C425134E20}" type="datetimeFigureOut">
              <a:rPr lang="it-IT" smtClean="0"/>
              <a:t>20/02/2023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198ABD15-2DC2-40A7-BD07-DA35778649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BC2FD93E-6524-4AEA-B4E3-5ECFEFB28C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D522D7-FB83-401B-B905-A026F952479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08430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AF906B77-EE60-4A03-AF3A-E7137C1719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0B74D03F-6E60-4358-8A32-C4F183F8CBF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B83F2E43-6D49-43FC-816E-B371EADD480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0B0716-A822-4170-BFBF-26C425134E20}" type="datetimeFigureOut">
              <a:rPr lang="it-IT" smtClean="0"/>
              <a:t>20/02/20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7B8638D9-F040-4713-BCEC-C1BC82D4EE6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C315B568-91F9-4B5E-B959-9D91BAD93FE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D522D7-FB83-401B-B905-A026F952479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341047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1" name="Gruppo 20">
            <a:extLst>
              <a:ext uri="{FF2B5EF4-FFF2-40B4-BE49-F238E27FC236}">
                <a16:creationId xmlns:a16="http://schemas.microsoft.com/office/drawing/2014/main" id="{15CAD7A7-4856-4749-BD22-EAEEE21E96CC}"/>
              </a:ext>
            </a:extLst>
          </p:cNvPr>
          <p:cNvGrpSpPr/>
          <p:nvPr/>
        </p:nvGrpSpPr>
        <p:grpSpPr>
          <a:xfrm>
            <a:off x="1509950" y="113930"/>
            <a:ext cx="7834348" cy="6486895"/>
            <a:chOff x="2355371" y="113930"/>
            <a:chExt cx="7883838" cy="5897491"/>
          </a:xfrm>
        </p:grpSpPr>
        <p:grpSp>
          <p:nvGrpSpPr>
            <p:cNvPr id="16" name="Gruppo 15">
              <a:extLst>
                <a:ext uri="{FF2B5EF4-FFF2-40B4-BE49-F238E27FC236}">
                  <a16:creationId xmlns:a16="http://schemas.microsoft.com/office/drawing/2014/main" id="{330172E6-1883-46A9-8E55-3381E9645509}"/>
                </a:ext>
              </a:extLst>
            </p:cNvPr>
            <p:cNvGrpSpPr/>
            <p:nvPr/>
          </p:nvGrpSpPr>
          <p:grpSpPr>
            <a:xfrm>
              <a:off x="2355371" y="113930"/>
              <a:ext cx="7883838" cy="5081597"/>
              <a:chOff x="1697849" y="105708"/>
              <a:chExt cx="9039793" cy="6658918"/>
            </a:xfrm>
          </p:grpSpPr>
          <p:grpSp>
            <p:nvGrpSpPr>
              <p:cNvPr id="3" name="Gruppo 2">
                <a:extLst>
                  <a:ext uri="{FF2B5EF4-FFF2-40B4-BE49-F238E27FC236}">
                    <a16:creationId xmlns:a16="http://schemas.microsoft.com/office/drawing/2014/main" id="{E6FFEF73-1AA2-44B5-A068-573C44F79A9D}"/>
                  </a:ext>
                </a:extLst>
              </p:cNvPr>
              <p:cNvGrpSpPr/>
              <p:nvPr/>
            </p:nvGrpSpPr>
            <p:grpSpPr>
              <a:xfrm>
                <a:off x="2012742" y="105708"/>
                <a:ext cx="8724900" cy="4869105"/>
                <a:chOff x="1602456" y="866262"/>
                <a:chExt cx="9215242" cy="5147027"/>
              </a:xfrm>
            </p:grpSpPr>
            <p:pic>
              <p:nvPicPr>
                <p:cNvPr id="4" name="Immagine 1">
                  <a:extLst>
                    <a:ext uri="{FF2B5EF4-FFF2-40B4-BE49-F238E27FC236}">
                      <a16:creationId xmlns:a16="http://schemas.microsoft.com/office/drawing/2014/main" id="{888870A1-3181-4023-9BD7-F1720FF4B6FA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1602456" y="866262"/>
                  <a:ext cx="9215242" cy="514702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sp>
              <p:nvSpPr>
                <p:cNvPr id="2" name="Rettangolo 1">
                  <a:extLst>
                    <a:ext uri="{FF2B5EF4-FFF2-40B4-BE49-F238E27FC236}">
                      <a16:creationId xmlns:a16="http://schemas.microsoft.com/office/drawing/2014/main" id="{1002FEEF-E4C0-4278-A2CC-4C97C22BCE8F}"/>
                    </a:ext>
                  </a:extLst>
                </p:cNvPr>
                <p:cNvSpPr/>
                <p:nvPr/>
              </p:nvSpPr>
              <p:spPr>
                <a:xfrm>
                  <a:off x="1704975" y="952500"/>
                  <a:ext cx="438150" cy="323850"/>
                </a:xfrm>
                <a:prstGeom prst="rect">
                  <a:avLst/>
                </a:prstGeom>
                <a:ln>
                  <a:noFill/>
                </a:ln>
              </p:spPr>
              <p:style>
                <a:lnRef idx="2">
                  <a:schemeClr val="accent6"/>
                </a:lnRef>
                <a:fillRef idx="1">
                  <a:schemeClr val="lt1"/>
                </a:fillRef>
                <a:effectRef idx="0">
                  <a:schemeClr val="accent6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</p:grpSp>
          <p:pic>
            <p:nvPicPr>
              <p:cNvPr id="9" name="Picture 7">
                <a:extLst>
                  <a:ext uri="{FF2B5EF4-FFF2-40B4-BE49-F238E27FC236}">
                    <a16:creationId xmlns:a16="http://schemas.microsoft.com/office/drawing/2014/main" id="{9B7286F6-2423-41B0-99F0-BB06D96D883F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11777"/>
              <a:stretch>
                <a:fillRect/>
              </a:stretch>
            </p:blipFill>
            <p:spPr bwMode="auto">
              <a:xfrm>
                <a:off x="2789604" y="5103592"/>
                <a:ext cx="7914017" cy="77719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10" name="AutoShape 4">
                <a:extLst>
                  <a:ext uri="{FF2B5EF4-FFF2-40B4-BE49-F238E27FC236}">
                    <a16:creationId xmlns:a16="http://schemas.microsoft.com/office/drawing/2014/main" id="{C7DC787E-BD28-44F8-9BAE-AB0B7FAAE2A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21480000">
                <a:off x="6317004" y="5007629"/>
                <a:ext cx="79377" cy="123825"/>
              </a:xfrm>
              <a:prstGeom prst="downArrow">
                <a:avLst>
                  <a:gd name="adj1" fmla="val 50000"/>
                  <a:gd name="adj2" fmla="val 35945"/>
                </a:avLst>
              </a:prstGeom>
              <a:solidFill>
                <a:srgbClr val="FF0000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eaVert"/>
              <a:lstStyle>
                <a:lvl1pPr eaLnBrk="0" hangingPunct="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it-IT" altLang="it-IT" sz="1800"/>
              </a:p>
            </p:txBody>
          </p:sp>
          <p:sp>
            <p:nvSpPr>
              <p:cNvPr id="11" name="CasellaDiTesto 29">
                <a:extLst>
                  <a:ext uri="{FF2B5EF4-FFF2-40B4-BE49-F238E27FC236}">
                    <a16:creationId xmlns:a16="http://schemas.microsoft.com/office/drawing/2014/main" id="{B1D6EF61-8D4E-479C-81CF-E5BB7EBFBD26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697849" y="5425616"/>
                <a:ext cx="1079524" cy="43999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algn="r" eaLnBrk="1" hangingPunct="1">
                  <a:spcBef>
                    <a:spcPct val="0"/>
                  </a:spcBef>
                  <a:buFontTx/>
                  <a:buNone/>
                </a:pPr>
                <a:r>
                  <a:rPr lang="en-GB" altLang="it-IT" sz="900" dirty="0"/>
                  <a:t>Clinical sample </a:t>
                </a:r>
              </a:p>
              <a:p>
                <a:pPr algn="r" eaLnBrk="1" hangingPunct="1">
                  <a:spcBef>
                    <a:spcPct val="0"/>
                  </a:spcBef>
                  <a:buFontTx/>
                  <a:buNone/>
                </a:pPr>
                <a:r>
                  <a:rPr lang="en-GB" altLang="it-IT" sz="900" dirty="0"/>
                  <a:t>Els-</a:t>
                </a:r>
                <a:r>
                  <a:rPr lang="en-GB" altLang="it-IT" sz="900" dirty="0" err="1"/>
                  <a:t>mai</a:t>
                </a:r>
                <a:r>
                  <a:rPr lang="en-GB" altLang="it-IT" sz="900" baseline="30000" dirty="0" err="1"/>
                  <a:t>a</a:t>
                </a:r>
                <a:endParaRPr lang="it-IT" altLang="it-IT" sz="900" baseline="30000" dirty="0"/>
              </a:p>
            </p:txBody>
          </p:sp>
          <p:pic>
            <p:nvPicPr>
              <p:cNvPr id="12" name="Picture 18">
                <a:extLst>
                  <a:ext uri="{FF2B5EF4-FFF2-40B4-BE49-F238E27FC236}">
                    <a16:creationId xmlns:a16="http://schemas.microsoft.com/office/drawing/2014/main" id="{B006424E-6C98-48B1-9BAC-41AA310A9FF3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10002"/>
              <a:stretch>
                <a:fillRect/>
              </a:stretch>
            </p:blipFill>
            <p:spPr bwMode="auto">
              <a:xfrm>
                <a:off x="2789604" y="6038777"/>
                <a:ext cx="7850177" cy="72008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13" name="AutoShape 4">
                <a:extLst>
                  <a:ext uri="{FF2B5EF4-FFF2-40B4-BE49-F238E27FC236}">
                    <a16:creationId xmlns:a16="http://schemas.microsoft.com/office/drawing/2014/main" id="{6DBD5DEA-2815-4A08-86C3-56D7BC76C39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21480000">
                <a:off x="6313194" y="5913604"/>
                <a:ext cx="79377" cy="123825"/>
              </a:xfrm>
              <a:prstGeom prst="downArrow">
                <a:avLst>
                  <a:gd name="adj1" fmla="val 50000"/>
                  <a:gd name="adj2" fmla="val 35945"/>
                </a:avLst>
              </a:prstGeom>
              <a:solidFill>
                <a:srgbClr val="FF0000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eaVert"/>
              <a:lstStyle>
                <a:lvl1pPr eaLnBrk="0" hangingPunct="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it-IT" altLang="it-IT" sz="1800"/>
              </a:p>
            </p:txBody>
          </p:sp>
          <p:sp>
            <p:nvSpPr>
              <p:cNvPr id="15" name="CasellaDiTesto 29">
                <a:extLst>
                  <a:ext uri="{FF2B5EF4-FFF2-40B4-BE49-F238E27FC236}">
                    <a16:creationId xmlns:a16="http://schemas.microsoft.com/office/drawing/2014/main" id="{26C202AC-5012-4815-A18C-4F8728F456F9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715602" y="6324628"/>
                <a:ext cx="1079524" cy="43999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algn="r" eaLnBrk="1" hangingPunct="1">
                  <a:spcBef>
                    <a:spcPct val="0"/>
                  </a:spcBef>
                  <a:buFontTx/>
                  <a:buNone/>
                </a:pPr>
                <a:r>
                  <a:rPr lang="en-GB" altLang="it-IT" sz="900" dirty="0"/>
                  <a:t>Clinical sample </a:t>
                </a:r>
              </a:p>
              <a:p>
                <a:pPr algn="r" eaLnBrk="1" hangingPunct="1">
                  <a:spcBef>
                    <a:spcPct val="0"/>
                  </a:spcBef>
                  <a:buFontTx/>
                  <a:buNone/>
                </a:pPr>
                <a:r>
                  <a:rPr lang="en-GB" altLang="it-IT" sz="900" dirty="0"/>
                  <a:t>Els-</a:t>
                </a:r>
                <a:r>
                  <a:rPr lang="en-GB" altLang="it-IT" sz="900" dirty="0" err="1"/>
                  <a:t>mai</a:t>
                </a:r>
                <a:r>
                  <a:rPr lang="en-GB" altLang="it-IT" sz="900" baseline="30000" dirty="0" err="1"/>
                  <a:t>b</a:t>
                </a:r>
                <a:endParaRPr lang="it-IT" altLang="it-IT" sz="900" baseline="30000" dirty="0"/>
              </a:p>
            </p:txBody>
          </p:sp>
        </p:grpSp>
        <p:pic>
          <p:nvPicPr>
            <p:cNvPr id="17" name="Picture 3">
              <a:extLst>
                <a:ext uri="{FF2B5EF4-FFF2-40B4-BE49-F238E27FC236}">
                  <a16:creationId xmlns:a16="http://schemas.microsoft.com/office/drawing/2014/main" id="{300BFD07-081F-4D0A-BC64-C968D6A63064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342"/>
            <a:stretch>
              <a:fillRect/>
            </a:stretch>
          </p:blipFill>
          <p:spPr bwMode="auto">
            <a:xfrm>
              <a:off x="3307517" y="5367256"/>
              <a:ext cx="6892497" cy="6441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9" name="CasellaDiTesto 29">
              <a:extLst>
                <a:ext uri="{FF2B5EF4-FFF2-40B4-BE49-F238E27FC236}">
                  <a16:creationId xmlns:a16="http://schemas.microsoft.com/office/drawing/2014/main" id="{73923745-6962-4EC9-9EA5-698DA1E3DA4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441642" y="5586518"/>
              <a:ext cx="856438" cy="33577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r" eaLnBrk="1" hangingPunct="1">
                <a:spcBef>
                  <a:spcPct val="0"/>
                </a:spcBef>
                <a:buFontTx/>
                <a:buNone/>
              </a:pPr>
              <a:r>
                <a:rPr lang="en-GB" altLang="it-IT" sz="900" dirty="0"/>
                <a:t>Clinical isolate V2921</a:t>
              </a:r>
              <a:endParaRPr lang="it-IT" altLang="it-IT" sz="900" dirty="0"/>
            </a:p>
          </p:txBody>
        </p:sp>
        <p:sp>
          <p:nvSpPr>
            <p:cNvPr id="20" name="AutoShape 4">
              <a:extLst>
                <a:ext uri="{FF2B5EF4-FFF2-40B4-BE49-F238E27FC236}">
                  <a16:creationId xmlns:a16="http://schemas.microsoft.com/office/drawing/2014/main" id="{A86B0535-F4B2-47E4-9C83-28C5912A3433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21480000">
              <a:off x="6399583" y="5279514"/>
              <a:ext cx="69227" cy="94494"/>
            </a:xfrm>
            <a:prstGeom prst="downArrow">
              <a:avLst>
                <a:gd name="adj1" fmla="val 50000"/>
                <a:gd name="adj2" fmla="val 35945"/>
              </a:avLst>
            </a:prstGeom>
            <a:solidFill>
              <a:srgbClr val="FF0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eaVert"/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it-IT" altLang="it-IT" sz="1800"/>
            </a:p>
          </p:txBody>
        </p:sp>
      </p:grpSp>
      <p:sp>
        <p:nvSpPr>
          <p:cNvPr id="5" name="Rettangolo 4">
            <a:extLst>
              <a:ext uri="{FF2B5EF4-FFF2-40B4-BE49-F238E27FC236}">
                <a16:creationId xmlns:a16="http://schemas.microsoft.com/office/drawing/2014/main" id="{AED16342-D6EB-4B13-B6DC-C91D402192E0}"/>
              </a:ext>
            </a:extLst>
          </p:cNvPr>
          <p:cNvSpPr/>
          <p:nvPr/>
        </p:nvSpPr>
        <p:spPr>
          <a:xfrm>
            <a:off x="9498634" y="6605488"/>
            <a:ext cx="269336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aseline="30000" dirty="0" err="1"/>
              <a:t>a</a:t>
            </a:r>
            <a:r>
              <a:rPr lang="en-US" sz="1000" dirty="0" err="1"/>
              <a:t>left</a:t>
            </a:r>
            <a:r>
              <a:rPr lang="en-US" sz="1000" dirty="0"/>
              <a:t> conjunctival swab; </a:t>
            </a:r>
            <a:r>
              <a:rPr lang="en-US" sz="1000" baseline="30000" dirty="0"/>
              <a:t>b</a:t>
            </a:r>
            <a:r>
              <a:rPr lang="en-US" sz="1000" dirty="0"/>
              <a:t>right conjunctival swab </a:t>
            </a:r>
            <a:endParaRPr lang="it-IT" sz="1000" dirty="0"/>
          </a:p>
        </p:txBody>
      </p:sp>
      <p:sp>
        <p:nvSpPr>
          <p:cNvPr id="8" name="CasellaDiTesto 29">
            <a:extLst>
              <a:ext uri="{FF2B5EF4-FFF2-40B4-BE49-F238E27FC236}">
                <a16:creationId xmlns:a16="http://schemas.microsoft.com/office/drawing/2014/main" id="{16AA7DA1-FEFD-4617-225D-848A537D0AF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91873" y="1407607"/>
            <a:ext cx="1295399" cy="3693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GB" altLang="it-IT" sz="900" dirty="0"/>
              <a:t>MHOM/IT/86/ISS218</a:t>
            </a:r>
          </a:p>
          <a:p>
            <a:pPr algn="r" eaLnBrk="1" hangingPunct="1">
              <a:spcBef>
                <a:spcPct val="0"/>
              </a:spcBef>
              <a:buFontTx/>
              <a:buNone/>
            </a:pPr>
            <a:endParaRPr lang="it-IT" altLang="it-IT" sz="900" dirty="0"/>
          </a:p>
        </p:txBody>
      </p:sp>
      <p:sp>
        <p:nvSpPr>
          <p:cNvPr id="14" name="CasellaDiTesto 29">
            <a:extLst>
              <a:ext uri="{FF2B5EF4-FFF2-40B4-BE49-F238E27FC236}">
                <a16:creationId xmlns:a16="http://schemas.microsoft.com/office/drawing/2014/main" id="{AFF01797-C94D-2D8F-B328-18A6CD8DF8D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11205" y="585613"/>
            <a:ext cx="1376067" cy="3693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>
            <a:spAutoFit/>
          </a:bodyPr>
          <a:lstStyle>
            <a:defPPr>
              <a:defRPr lang="it-IT"/>
            </a:defPPr>
            <a:lvl1pPr>
              <a:spcBef>
                <a:spcPct val="0"/>
              </a:spcBef>
              <a:buFontTx/>
              <a:buNone/>
              <a:defRPr sz="900"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latin typeface="Calibri" panose="020F0502020204030204" pitchFamily="34" charset="0"/>
              </a:defRPr>
            </a:lvl9pPr>
          </a:lstStyle>
          <a:p>
            <a:pPr algn="r"/>
            <a:r>
              <a:rPr lang="en-GB" altLang="it-IT" dirty="0"/>
              <a:t>MHOM/TN/80/IPT1</a:t>
            </a:r>
          </a:p>
          <a:p>
            <a:pPr algn="r"/>
            <a:endParaRPr lang="it-IT" altLang="it-IT" dirty="0"/>
          </a:p>
        </p:txBody>
      </p:sp>
      <p:sp>
        <p:nvSpPr>
          <p:cNvPr id="18" name="CasellaDiTesto 29">
            <a:extLst>
              <a:ext uri="{FF2B5EF4-FFF2-40B4-BE49-F238E27FC236}">
                <a16:creationId xmlns:a16="http://schemas.microsoft.com/office/drawing/2014/main" id="{6FCDC3E5-ED52-3195-6E5D-C8DF06BC827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91873" y="2229241"/>
            <a:ext cx="1295399" cy="3693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GB" altLang="it-IT" sz="900" dirty="0"/>
              <a:t>MHOM/IT/93/ISS822</a:t>
            </a:r>
          </a:p>
          <a:p>
            <a:pPr algn="r" eaLnBrk="1" hangingPunct="1">
              <a:spcBef>
                <a:spcPct val="0"/>
              </a:spcBef>
              <a:buFontTx/>
              <a:buNone/>
            </a:pPr>
            <a:endParaRPr lang="it-IT" altLang="it-IT" sz="900" dirty="0"/>
          </a:p>
        </p:txBody>
      </p:sp>
      <p:sp>
        <p:nvSpPr>
          <p:cNvPr id="22" name="CasellaDiTesto 29">
            <a:extLst>
              <a:ext uri="{FF2B5EF4-FFF2-40B4-BE49-F238E27FC236}">
                <a16:creationId xmlns:a16="http://schemas.microsoft.com/office/drawing/2014/main" id="{D9C1B78C-5EAF-2873-B39F-4862C00E629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91873" y="2996966"/>
            <a:ext cx="1295399" cy="3693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GB" altLang="it-IT" sz="900" dirty="0"/>
              <a:t>MHOM/DZ/82/LIPA59</a:t>
            </a:r>
          </a:p>
          <a:p>
            <a:pPr algn="r" eaLnBrk="1" hangingPunct="1">
              <a:spcBef>
                <a:spcPct val="0"/>
              </a:spcBef>
              <a:buFontTx/>
              <a:buNone/>
            </a:pPr>
            <a:endParaRPr lang="it-IT" altLang="it-IT" sz="900" dirty="0"/>
          </a:p>
        </p:txBody>
      </p:sp>
      <p:sp>
        <p:nvSpPr>
          <p:cNvPr id="23" name="CasellaDiTesto 29">
            <a:extLst>
              <a:ext uri="{FF2B5EF4-FFF2-40B4-BE49-F238E27FC236}">
                <a16:creationId xmlns:a16="http://schemas.microsoft.com/office/drawing/2014/main" id="{70288604-5D44-90E7-4DC4-48CD62615C9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91873" y="3811705"/>
            <a:ext cx="1295399" cy="3693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GB" altLang="it-IT" sz="900" dirty="0"/>
              <a:t>MHOM/ES/81/BCN1</a:t>
            </a:r>
          </a:p>
          <a:p>
            <a:pPr algn="r" eaLnBrk="1" hangingPunct="1">
              <a:spcBef>
                <a:spcPct val="0"/>
              </a:spcBef>
              <a:buFontTx/>
              <a:buNone/>
            </a:pPr>
            <a:endParaRPr lang="it-IT" altLang="it-IT" sz="900" dirty="0"/>
          </a:p>
        </p:txBody>
      </p:sp>
    </p:spTree>
    <p:extLst>
      <p:ext uri="{BB962C8B-B14F-4D97-AF65-F5344CB8AC3E}">
        <p14:creationId xmlns:p14="http://schemas.microsoft.com/office/powerpoint/2010/main" val="124325017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5</TotalTime>
  <Words>51</Words>
  <Application>Microsoft Office PowerPoint</Application>
  <PresentationFormat>Widescreen</PresentationFormat>
  <Paragraphs>11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i Office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User</dc:creator>
  <cp:lastModifiedBy>luca galluzzi</cp:lastModifiedBy>
  <cp:revision>6</cp:revision>
  <dcterms:created xsi:type="dcterms:W3CDTF">2022-01-21T17:20:08Z</dcterms:created>
  <dcterms:modified xsi:type="dcterms:W3CDTF">2023-02-20T13:30:12Z</dcterms:modified>
</cp:coreProperties>
</file>